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58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2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662" y="4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419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60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328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837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450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0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316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62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727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27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28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754E69-AA64-4AC1-ABFC-52C928ABB20E}" type="datetimeFigureOut">
              <a:rPr lang="en-US" smtClean="0"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97A8F-675A-4F35-9260-BFA015C4A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959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09325" y="1337450"/>
            <a:ext cx="75598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Rsp673_06495  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 regulator Lys R family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258955" y="2278735"/>
            <a:ext cx="8498679" cy="2834177"/>
            <a:chOff x="258955" y="2278735"/>
            <a:chExt cx="8498679" cy="2834177"/>
          </a:xfrm>
        </p:grpSpPr>
        <p:grpSp>
          <p:nvGrpSpPr>
            <p:cNvPr id="6" name="Group 5"/>
            <p:cNvGrpSpPr/>
            <p:nvPr/>
          </p:nvGrpSpPr>
          <p:grpSpPr>
            <a:xfrm>
              <a:off x="258955" y="2851043"/>
              <a:ext cx="8498679" cy="2261869"/>
              <a:chOff x="258955" y="2798695"/>
              <a:chExt cx="8383093" cy="199850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630414" y="2798695"/>
                <a:ext cx="6935635" cy="454295"/>
                <a:chOff x="1658939" y="2951402"/>
                <a:chExt cx="6935635" cy="454295"/>
              </a:xfrm>
            </p:grpSpPr>
            <p:sp>
              <p:nvSpPr>
                <p:cNvPr id="29" name="Freeform 410"/>
                <p:cNvSpPr>
                  <a:spLocks/>
                </p:cNvSpPr>
                <p:nvPr/>
              </p:nvSpPr>
              <p:spPr bwMode="auto">
                <a:xfrm>
                  <a:off x="1658939" y="3154783"/>
                  <a:ext cx="5718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0" name="Freeform 410"/>
                <p:cNvSpPr>
                  <a:spLocks/>
                </p:cNvSpPr>
                <p:nvPr/>
              </p:nvSpPr>
              <p:spPr bwMode="auto">
                <a:xfrm>
                  <a:off x="2298700" y="3154783"/>
                  <a:ext cx="5718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" name="Freeform 410"/>
                <p:cNvSpPr>
                  <a:spLocks/>
                </p:cNvSpPr>
                <p:nvPr/>
              </p:nvSpPr>
              <p:spPr bwMode="auto">
                <a:xfrm>
                  <a:off x="2933701" y="3154783"/>
                  <a:ext cx="1389380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" name="Freeform 410"/>
                <p:cNvSpPr>
                  <a:spLocks/>
                </p:cNvSpPr>
                <p:nvPr/>
              </p:nvSpPr>
              <p:spPr bwMode="auto">
                <a:xfrm>
                  <a:off x="4351656" y="3154783"/>
                  <a:ext cx="332421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3" name="Freeform 410"/>
                <p:cNvSpPr>
                  <a:spLocks/>
                </p:cNvSpPr>
                <p:nvPr/>
              </p:nvSpPr>
              <p:spPr bwMode="auto">
                <a:xfrm>
                  <a:off x="4731070" y="3154783"/>
                  <a:ext cx="301941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" name="Freeform 410"/>
                <p:cNvSpPr>
                  <a:spLocks/>
                </p:cNvSpPr>
                <p:nvPr/>
              </p:nvSpPr>
              <p:spPr bwMode="auto">
                <a:xfrm flipH="1">
                  <a:off x="5080004" y="2951402"/>
                  <a:ext cx="281621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" name="Freeform 410"/>
                <p:cNvSpPr>
                  <a:spLocks/>
                </p:cNvSpPr>
                <p:nvPr/>
              </p:nvSpPr>
              <p:spPr bwMode="auto">
                <a:xfrm>
                  <a:off x="5471643" y="3154783"/>
                  <a:ext cx="5718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6" name="Freeform 410"/>
                <p:cNvSpPr>
                  <a:spLocks/>
                </p:cNvSpPr>
                <p:nvPr/>
              </p:nvSpPr>
              <p:spPr bwMode="auto">
                <a:xfrm flipH="1">
                  <a:off x="6146007" y="2951402"/>
                  <a:ext cx="281621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" name="Freeform 410"/>
                <p:cNvSpPr>
                  <a:spLocks/>
                </p:cNvSpPr>
                <p:nvPr/>
              </p:nvSpPr>
              <p:spPr bwMode="auto">
                <a:xfrm>
                  <a:off x="6454776" y="3154783"/>
                  <a:ext cx="5718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" name="Freeform 410"/>
                <p:cNvSpPr>
                  <a:spLocks/>
                </p:cNvSpPr>
                <p:nvPr/>
              </p:nvSpPr>
              <p:spPr bwMode="auto">
                <a:xfrm>
                  <a:off x="7053742" y="3154783"/>
                  <a:ext cx="5718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" name="Freeform 410"/>
                <p:cNvSpPr>
                  <a:spLocks/>
                </p:cNvSpPr>
                <p:nvPr/>
              </p:nvSpPr>
              <p:spPr bwMode="auto">
                <a:xfrm>
                  <a:off x="7728590" y="3154783"/>
                  <a:ext cx="4194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" name="Freeform 410"/>
                <p:cNvSpPr>
                  <a:spLocks/>
                </p:cNvSpPr>
                <p:nvPr/>
              </p:nvSpPr>
              <p:spPr bwMode="auto">
                <a:xfrm>
                  <a:off x="8175156" y="3154783"/>
                  <a:ext cx="4194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258955" y="3430537"/>
                <a:ext cx="1481437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soprenylcysteine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carboxyl methyltransferase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205263" y="4069808"/>
                <a:ext cx="120904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utathione S-transfer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Straight Arrow Connector 9"/>
              <p:cNvCxnSpPr>
                <a:stCxn id="8" idx="0"/>
              </p:cNvCxnSpPr>
              <p:nvPr/>
            </p:nvCxnSpPr>
            <p:spPr>
              <a:xfrm flipH="1" flipV="1">
                <a:off x="916323" y="3252990"/>
                <a:ext cx="83351" cy="177547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/>
              <p:cNvCxnSpPr/>
              <p:nvPr/>
            </p:nvCxnSpPr>
            <p:spPr>
              <a:xfrm flipV="1">
                <a:off x="1733128" y="3252991"/>
                <a:ext cx="7264" cy="816817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2101885" y="3430537"/>
                <a:ext cx="148143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cyl-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oA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dehydrogen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Straight Arrow Connector 12"/>
              <p:cNvCxnSpPr/>
              <p:nvPr/>
            </p:nvCxnSpPr>
            <p:spPr>
              <a:xfrm flipV="1">
                <a:off x="2599866" y="3251454"/>
                <a:ext cx="3674" cy="179083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2748622" y="3931249"/>
                <a:ext cx="14814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othetical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3489340" y="3292037"/>
                <a:ext cx="3632" cy="63695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/>
              <p:cNvCxnSpPr/>
              <p:nvPr/>
            </p:nvCxnSpPr>
            <p:spPr>
              <a:xfrm flipV="1">
                <a:off x="3660127" y="3202108"/>
                <a:ext cx="204542" cy="726888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/>
              <p:cNvCxnSpPr/>
              <p:nvPr/>
            </p:nvCxnSpPr>
            <p:spPr>
              <a:xfrm flipV="1">
                <a:off x="3799006" y="3079722"/>
                <a:ext cx="362765" cy="849274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4459466" y="3565552"/>
                <a:ext cx="12325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yoxal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5113808" y="3076814"/>
                <a:ext cx="69706" cy="48873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4937235" y="3878115"/>
                <a:ext cx="154985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minoglycosidase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phosphotransfer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606034" y="3513719"/>
                <a:ext cx="154985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ructose-2-6-bisphosphat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092198" y="4104698"/>
                <a:ext cx="154985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-hydroxyacyl-CoA dehydrogen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Straight Arrow Connector 23"/>
              <p:cNvCxnSpPr>
                <a:stCxn id="22" idx="0"/>
              </p:cNvCxnSpPr>
              <p:nvPr/>
            </p:nvCxnSpPr>
            <p:spPr>
              <a:xfrm flipH="1" flipV="1">
                <a:off x="6328772" y="3202109"/>
                <a:ext cx="52187" cy="31161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5613882" y="3292037"/>
                <a:ext cx="3632" cy="63695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7423270" y="3424251"/>
                <a:ext cx="3632" cy="63695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/>
              <p:cNvSpPr txBox="1"/>
              <p:nvPr/>
            </p:nvSpPr>
            <p:spPr>
              <a:xfrm>
                <a:off x="6316306" y="4335530"/>
                <a:ext cx="87795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noyl-coA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hydrat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" name="Straight Arrow Connector 27"/>
              <p:cNvCxnSpPr/>
              <p:nvPr/>
            </p:nvCxnSpPr>
            <p:spPr>
              <a:xfrm flipV="1">
                <a:off x="6874321" y="3292037"/>
                <a:ext cx="79040" cy="1008604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TextBox 40"/>
            <p:cNvSpPr txBox="1"/>
            <p:nvPr/>
          </p:nvSpPr>
          <p:spPr>
            <a:xfrm>
              <a:off x="4165877" y="2278735"/>
              <a:ext cx="1249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p673_0649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 flipH="1">
              <a:off x="4725291" y="2562896"/>
              <a:ext cx="1255" cy="482931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139909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11172" y="1327643"/>
            <a:ext cx="777883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p673_07855  </a:t>
            </a: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 regulator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aC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amily</a:t>
            </a:r>
          </a:p>
        </p:txBody>
      </p:sp>
      <p:grpSp>
        <p:nvGrpSpPr>
          <p:cNvPr id="42" name="Group 41"/>
          <p:cNvGrpSpPr/>
          <p:nvPr/>
        </p:nvGrpSpPr>
        <p:grpSpPr>
          <a:xfrm>
            <a:off x="253128" y="2240285"/>
            <a:ext cx="8637743" cy="2769783"/>
            <a:chOff x="253128" y="2240285"/>
            <a:chExt cx="8637743" cy="2769783"/>
          </a:xfrm>
        </p:grpSpPr>
        <p:grpSp>
          <p:nvGrpSpPr>
            <p:cNvPr id="4" name="Group 3"/>
            <p:cNvGrpSpPr/>
            <p:nvPr/>
          </p:nvGrpSpPr>
          <p:grpSpPr>
            <a:xfrm>
              <a:off x="253128" y="2534321"/>
              <a:ext cx="8637743" cy="2475747"/>
              <a:chOff x="-55085" y="2560079"/>
              <a:chExt cx="8637743" cy="2475747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-55085" y="4541398"/>
                <a:ext cx="12287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S Ribosomal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10579" y="3735891"/>
                <a:ext cx="21043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enylalanyl-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tRNA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synthase units alpha-bet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" name="Straight Arrow Connector 6"/>
              <p:cNvCxnSpPr/>
              <p:nvPr/>
            </p:nvCxnSpPr>
            <p:spPr>
              <a:xfrm flipV="1">
                <a:off x="186147" y="3226506"/>
                <a:ext cx="138090" cy="1314892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Arrow Connector 7"/>
              <p:cNvCxnSpPr/>
              <p:nvPr/>
            </p:nvCxnSpPr>
            <p:spPr>
              <a:xfrm flipH="1" flipV="1">
                <a:off x="987483" y="3162067"/>
                <a:ext cx="5553" cy="58636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2588032" y="3748432"/>
                <a:ext cx="8384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tegr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Straight Arrow Connector 9"/>
              <p:cNvCxnSpPr/>
              <p:nvPr/>
            </p:nvCxnSpPr>
            <p:spPr>
              <a:xfrm flipV="1">
                <a:off x="2181979" y="3196706"/>
                <a:ext cx="23869" cy="53918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3407442" y="4112496"/>
                <a:ext cx="11716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tRNA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Pro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3009631" y="3162066"/>
                <a:ext cx="3632" cy="63695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H="1" flipV="1">
                <a:off x="3749757" y="3233736"/>
                <a:ext cx="183326" cy="87814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/>
              <p:nvPr/>
            </p:nvCxnSpPr>
            <p:spPr>
              <a:xfrm flipV="1">
                <a:off x="3327237" y="3225808"/>
                <a:ext cx="91430" cy="1163687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Arrow Connector 14"/>
              <p:cNvCxnSpPr/>
              <p:nvPr/>
            </p:nvCxnSpPr>
            <p:spPr>
              <a:xfrm>
                <a:off x="4442252" y="2560079"/>
                <a:ext cx="7264" cy="64436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4081819" y="3748432"/>
                <a:ext cx="162946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lkylhydroperoxidase</a:t>
                </a:r>
                <a:endParaRPr lang="en-US" sz="12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786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Straight Arrow Connector 16"/>
              <p:cNvCxnSpPr/>
              <p:nvPr/>
            </p:nvCxnSpPr>
            <p:spPr>
              <a:xfrm flipV="1">
                <a:off x="5133059" y="3259694"/>
                <a:ext cx="69706" cy="48873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5204530" y="4302175"/>
                <a:ext cx="15498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ldose 1-epimer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130623" y="3761101"/>
                <a:ext cx="10864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othetical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7655995" y="3830162"/>
                <a:ext cx="92666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minoacid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perme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" name="Straight Arrow Connector 20"/>
              <p:cNvCxnSpPr/>
              <p:nvPr/>
            </p:nvCxnSpPr>
            <p:spPr>
              <a:xfrm flipH="1" flipV="1">
                <a:off x="6188121" y="3214242"/>
                <a:ext cx="283880" cy="53419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5837544" y="3399415"/>
                <a:ext cx="0" cy="85158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/>
              <p:cNvCxnSpPr/>
              <p:nvPr/>
            </p:nvCxnSpPr>
            <p:spPr>
              <a:xfrm flipV="1">
                <a:off x="8038112" y="3204444"/>
                <a:ext cx="3632" cy="63695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7091529" y="4389495"/>
                <a:ext cx="119418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NA polymerase IV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Straight Arrow Connector 24"/>
              <p:cNvCxnSpPr/>
              <p:nvPr/>
            </p:nvCxnSpPr>
            <p:spPr>
              <a:xfrm flipH="1" flipV="1">
                <a:off x="6907815" y="3188952"/>
                <a:ext cx="621924" cy="1200543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6" name="Group 25"/>
              <p:cNvGrpSpPr/>
              <p:nvPr/>
            </p:nvGrpSpPr>
            <p:grpSpPr>
              <a:xfrm>
                <a:off x="186147" y="2943775"/>
                <a:ext cx="8059078" cy="487320"/>
                <a:chOff x="186147" y="2943775"/>
                <a:chExt cx="8059078" cy="487320"/>
              </a:xfrm>
            </p:grpSpPr>
            <p:sp>
              <p:nvSpPr>
                <p:cNvPr id="28" name="Freeform 410"/>
                <p:cNvSpPr>
                  <a:spLocks/>
                </p:cNvSpPr>
                <p:nvPr/>
              </p:nvSpPr>
              <p:spPr bwMode="auto">
                <a:xfrm>
                  <a:off x="3908212" y="3180181"/>
                  <a:ext cx="1082609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9" name="Freeform 410"/>
                <p:cNvSpPr>
                  <a:spLocks/>
                </p:cNvSpPr>
                <p:nvPr/>
              </p:nvSpPr>
              <p:spPr bwMode="auto">
                <a:xfrm>
                  <a:off x="5445502" y="3180181"/>
                  <a:ext cx="57181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grpSp>
              <p:nvGrpSpPr>
                <p:cNvPr id="30" name="Group 29"/>
                <p:cNvGrpSpPr/>
                <p:nvPr/>
              </p:nvGrpSpPr>
              <p:grpSpPr>
                <a:xfrm>
                  <a:off x="186147" y="2943775"/>
                  <a:ext cx="8059078" cy="250914"/>
                  <a:chOff x="223601" y="2980601"/>
                  <a:chExt cx="8059078" cy="250914"/>
                </a:xfrm>
              </p:grpSpPr>
              <p:sp>
                <p:nvSpPr>
                  <p:cNvPr id="31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223601" y="2980601"/>
                    <a:ext cx="433624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96201" y="2980601"/>
                    <a:ext cx="736214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1463967" y="2980601"/>
                    <a:ext cx="1389380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2941818" y="2980601"/>
                    <a:ext cx="332421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3313215" y="2980601"/>
                    <a:ext cx="301941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5136733" y="2980601"/>
                    <a:ext cx="281621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050268" y="2980601"/>
                    <a:ext cx="349942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440328" y="2980601"/>
                    <a:ext cx="71009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7187486" y="2980601"/>
                    <a:ext cx="1095193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" name="Rectangle 39"/>
                  <p:cNvSpPr/>
                  <p:nvPr/>
                </p:nvSpPr>
                <p:spPr>
                  <a:xfrm>
                    <a:off x="3656133" y="3038772"/>
                    <a:ext cx="189431" cy="134573"/>
                  </a:xfrm>
                  <a:prstGeom prst="rect">
                    <a:avLst/>
                  </a:prstGeom>
                  <a:solidFill>
                    <a:srgbClr val="00B05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27" name="TextBox 26"/>
              <p:cNvSpPr txBox="1"/>
              <p:nvPr/>
            </p:nvSpPr>
            <p:spPr>
              <a:xfrm>
                <a:off x="2664085" y="4389495"/>
                <a:ext cx="120904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erR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family transcriptional regulator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" name="TextBox 40"/>
            <p:cNvSpPr txBox="1"/>
            <p:nvPr/>
          </p:nvSpPr>
          <p:spPr>
            <a:xfrm>
              <a:off x="3974228" y="2240285"/>
              <a:ext cx="16294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p673_0785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75720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69701" y="1265226"/>
            <a:ext cx="77530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Rsp673_09075  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 regulator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sR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amily</a:t>
            </a:r>
          </a:p>
        </p:txBody>
      </p:sp>
      <p:grpSp>
        <p:nvGrpSpPr>
          <p:cNvPr id="39" name="Group 38"/>
          <p:cNvGrpSpPr/>
          <p:nvPr/>
        </p:nvGrpSpPr>
        <p:grpSpPr>
          <a:xfrm>
            <a:off x="-55085" y="2205918"/>
            <a:ext cx="9169909" cy="2710464"/>
            <a:chOff x="-55085" y="2205918"/>
            <a:chExt cx="9169909" cy="2710464"/>
          </a:xfrm>
        </p:grpSpPr>
        <p:grpSp>
          <p:nvGrpSpPr>
            <p:cNvPr id="5" name="Group 4"/>
            <p:cNvGrpSpPr/>
            <p:nvPr/>
          </p:nvGrpSpPr>
          <p:grpSpPr>
            <a:xfrm>
              <a:off x="-55085" y="2578582"/>
              <a:ext cx="9169909" cy="2337800"/>
              <a:chOff x="-55085" y="2578582"/>
              <a:chExt cx="9169909" cy="2337800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-55085" y="4541398"/>
                <a:ext cx="12287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S Ribosomal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860133" y="3707161"/>
                <a:ext cx="10700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oxin 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p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Straight Arrow Connector 7"/>
              <p:cNvCxnSpPr/>
              <p:nvPr/>
            </p:nvCxnSpPr>
            <p:spPr>
              <a:xfrm flipV="1">
                <a:off x="186147" y="3226506"/>
                <a:ext cx="138090" cy="1314892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Arrow Connector 8"/>
              <p:cNvCxnSpPr/>
              <p:nvPr/>
            </p:nvCxnSpPr>
            <p:spPr>
              <a:xfrm flipH="1" flipV="1">
                <a:off x="1404617" y="3150076"/>
                <a:ext cx="5553" cy="58636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1978392" y="3748432"/>
                <a:ext cx="144812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BC transporter perme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Straight Arrow Connector 10"/>
              <p:cNvCxnSpPr/>
              <p:nvPr/>
            </p:nvCxnSpPr>
            <p:spPr>
              <a:xfrm flipV="1">
                <a:off x="2781266" y="3162067"/>
                <a:ext cx="3632" cy="63695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>
              <a:xfrm flipV="1">
                <a:off x="3508459" y="3187225"/>
                <a:ext cx="91430" cy="1163687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>
                <a:off x="4442252" y="2578582"/>
                <a:ext cx="7264" cy="64436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4536986" y="3702265"/>
                <a:ext cx="162946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ta-lactamase</a:t>
                </a:r>
              </a:p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08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5391782" y="3222947"/>
                <a:ext cx="69706" cy="48873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5910878" y="3743164"/>
                <a:ext cx="108646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tein disulfide isomer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635489" y="4454717"/>
                <a:ext cx="247933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tocatechuate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2, 4 dioxygenase subunits alpha, bet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H="1" flipV="1">
                <a:off x="6312169" y="3213451"/>
                <a:ext cx="14773" cy="52299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/>
              <p:cNvCxnSpPr/>
              <p:nvPr/>
            </p:nvCxnSpPr>
            <p:spPr>
              <a:xfrm flipV="1">
                <a:off x="7537314" y="3412927"/>
                <a:ext cx="401200" cy="1091601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6805453" y="3792474"/>
                <a:ext cx="849446" cy="468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-5’ RNA lig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" name="Straight Arrow Connector 20"/>
              <p:cNvCxnSpPr/>
              <p:nvPr/>
            </p:nvCxnSpPr>
            <p:spPr>
              <a:xfrm flipH="1" flipV="1">
                <a:off x="7068496" y="3426398"/>
                <a:ext cx="35056" cy="372628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2877356" y="4366029"/>
                <a:ext cx="12090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fs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transporter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Group 22"/>
              <p:cNvGrpSpPr/>
              <p:nvPr/>
            </p:nvGrpSpPr>
            <p:grpSpPr>
              <a:xfrm>
                <a:off x="186147" y="2943030"/>
                <a:ext cx="8797502" cy="525071"/>
                <a:chOff x="186147" y="2943030"/>
                <a:chExt cx="8797502" cy="525071"/>
              </a:xfrm>
            </p:grpSpPr>
            <p:grpSp>
              <p:nvGrpSpPr>
                <p:cNvPr id="25" name="Group 24"/>
                <p:cNvGrpSpPr/>
                <p:nvPr/>
              </p:nvGrpSpPr>
              <p:grpSpPr>
                <a:xfrm>
                  <a:off x="186147" y="2943030"/>
                  <a:ext cx="6560194" cy="250914"/>
                  <a:chOff x="186147" y="2943030"/>
                  <a:chExt cx="6560194" cy="250914"/>
                </a:xfrm>
              </p:grpSpPr>
              <p:sp>
                <p:nvSpPr>
                  <p:cNvPr id="31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186147" y="2943030"/>
                    <a:ext cx="433624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56830" y="2943030"/>
                    <a:ext cx="1703038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2448585" y="2943030"/>
                    <a:ext cx="788200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3275760" y="2943030"/>
                    <a:ext cx="610402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5033269" y="2943030"/>
                    <a:ext cx="876476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061091" y="2943030"/>
                    <a:ext cx="685250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26" name="Group 25"/>
                <p:cNvGrpSpPr/>
                <p:nvPr/>
              </p:nvGrpSpPr>
              <p:grpSpPr>
                <a:xfrm>
                  <a:off x="3908212" y="3217187"/>
                  <a:ext cx="5075437" cy="250914"/>
                  <a:chOff x="3908212" y="3217187"/>
                  <a:chExt cx="5075437" cy="250914"/>
                </a:xfrm>
              </p:grpSpPr>
              <p:sp>
                <p:nvSpPr>
                  <p:cNvPr id="27" name="Freeform 410"/>
                  <p:cNvSpPr>
                    <a:spLocks/>
                  </p:cNvSpPr>
                  <p:nvPr/>
                </p:nvSpPr>
                <p:spPr bwMode="auto">
                  <a:xfrm>
                    <a:off x="3908212" y="3217187"/>
                    <a:ext cx="108260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solidFill>
                    <a:schemeClr val="accent1">
                      <a:lumMod val="75000"/>
                    </a:schemeClr>
                  </a:solidFill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" name="Freeform 410"/>
                  <p:cNvSpPr>
                    <a:spLocks/>
                  </p:cNvSpPr>
                  <p:nvPr/>
                </p:nvSpPr>
                <p:spPr bwMode="auto">
                  <a:xfrm>
                    <a:off x="6815874" y="3217187"/>
                    <a:ext cx="71009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" name="Freeform 410"/>
                  <p:cNvSpPr>
                    <a:spLocks/>
                  </p:cNvSpPr>
                  <p:nvPr/>
                </p:nvSpPr>
                <p:spPr bwMode="auto">
                  <a:xfrm>
                    <a:off x="7551406" y="3217187"/>
                    <a:ext cx="716122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" name="Freeform 410"/>
                  <p:cNvSpPr>
                    <a:spLocks/>
                  </p:cNvSpPr>
                  <p:nvPr/>
                </p:nvSpPr>
                <p:spPr bwMode="auto">
                  <a:xfrm>
                    <a:off x="8267527" y="3217187"/>
                    <a:ext cx="716122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</p:grpSp>
          <p:cxnSp>
            <p:nvCxnSpPr>
              <p:cNvPr id="24" name="Straight Arrow Connector 23"/>
              <p:cNvCxnSpPr/>
              <p:nvPr/>
            </p:nvCxnSpPr>
            <p:spPr>
              <a:xfrm flipV="1">
                <a:off x="8065946" y="3417963"/>
                <a:ext cx="579844" cy="1036754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/>
            <p:cNvSpPr txBox="1"/>
            <p:nvPr/>
          </p:nvSpPr>
          <p:spPr>
            <a:xfrm>
              <a:off x="3580961" y="2205918"/>
              <a:ext cx="16294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p673_0907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4849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43951" y="1306736"/>
            <a:ext cx="702435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Rsp673_16370-Rsp673_16375 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-component system regulator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xR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amily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-7932" y="2988027"/>
            <a:ext cx="9164660" cy="2440141"/>
            <a:chOff x="-7932" y="2988027"/>
            <a:chExt cx="9164660" cy="2440141"/>
          </a:xfrm>
        </p:grpSpPr>
        <p:sp>
          <p:nvSpPr>
            <p:cNvPr id="4" name="TextBox 3"/>
            <p:cNvSpPr txBox="1"/>
            <p:nvPr/>
          </p:nvSpPr>
          <p:spPr>
            <a:xfrm>
              <a:off x="-7932" y="4039931"/>
              <a:ext cx="12287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gnal peptide prote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54538" y="4966503"/>
              <a:ext cx="20863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atidylethanolamine-binding prote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V="1">
              <a:off x="632374" y="3264040"/>
              <a:ext cx="101340" cy="750792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 flipV="1">
              <a:off x="1267867" y="3537761"/>
              <a:ext cx="25079" cy="1381801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031536" y="4634302"/>
              <a:ext cx="144812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nganese transporte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 flipV="1">
              <a:off x="1868470" y="3218329"/>
              <a:ext cx="27341" cy="424297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 flipV="1">
              <a:off x="2514362" y="3361426"/>
              <a:ext cx="22433" cy="597699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 flipV="1">
              <a:off x="3745452" y="3454174"/>
              <a:ext cx="80683" cy="560658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4611088" y="4893111"/>
              <a:ext cx="16294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ytochrome-C peroxidase 1638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/>
            <p:cNvCxnSpPr>
              <a:stCxn id="12" idx="0"/>
            </p:cNvCxnSpPr>
            <p:nvPr/>
          </p:nvCxnSpPr>
          <p:spPr>
            <a:xfrm flipV="1">
              <a:off x="5425823" y="3509234"/>
              <a:ext cx="0" cy="1383877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5861267" y="4430037"/>
              <a:ext cx="10864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D transporter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38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149516" y="4446533"/>
              <a:ext cx="10890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la prote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 flipV="1">
              <a:off x="6272725" y="3558577"/>
              <a:ext cx="21984" cy="871460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>
              <a:stCxn id="15" idx="0"/>
            </p:cNvCxnSpPr>
            <p:nvPr/>
          </p:nvCxnSpPr>
          <p:spPr>
            <a:xfrm flipH="1" flipV="1">
              <a:off x="7654899" y="3264041"/>
              <a:ext cx="39144" cy="1182492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6532803" y="3709374"/>
              <a:ext cx="10818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D transporter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39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 flipH="1" flipV="1">
              <a:off x="6930202" y="3322919"/>
              <a:ext cx="35056" cy="372628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935365" y="4014832"/>
              <a:ext cx="136117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wo-component Histidine kinase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37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 flipV="1">
              <a:off x="8196465" y="3514435"/>
              <a:ext cx="248406" cy="1395573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>
              <a:stCxn id="24" idx="0"/>
            </p:cNvCxnSpPr>
            <p:nvPr/>
          </p:nvCxnSpPr>
          <p:spPr>
            <a:xfrm flipH="1" flipV="1">
              <a:off x="4540725" y="3320523"/>
              <a:ext cx="198212" cy="667448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>
              <a:stCxn id="8" idx="0"/>
            </p:cNvCxnSpPr>
            <p:nvPr/>
          </p:nvCxnSpPr>
          <p:spPr>
            <a:xfrm flipV="1">
              <a:off x="2755598" y="3319445"/>
              <a:ext cx="171137" cy="1314857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4134417" y="3987971"/>
              <a:ext cx="120904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wo-component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ux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gulator 1637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322377" y="4919562"/>
              <a:ext cx="18343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emotaxis proteins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Z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nd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e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" name="Group 25"/>
            <p:cNvGrpSpPr/>
            <p:nvPr/>
          </p:nvGrpSpPr>
          <p:grpSpPr>
            <a:xfrm>
              <a:off x="535548" y="2988027"/>
              <a:ext cx="8230754" cy="509723"/>
              <a:chOff x="535548" y="2988027"/>
              <a:chExt cx="8230754" cy="509723"/>
            </a:xfrm>
          </p:grpSpPr>
          <p:grpSp>
            <p:nvGrpSpPr>
              <p:cNvPr id="30" name="Group 29"/>
              <p:cNvGrpSpPr/>
              <p:nvPr/>
            </p:nvGrpSpPr>
            <p:grpSpPr>
              <a:xfrm>
                <a:off x="535548" y="2988027"/>
                <a:ext cx="7490222" cy="250914"/>
                <a:chOff x="1170242" y="2959311"/>
                <a:chExt cx="7490222" cy="250914"/>
              </a:xfrm>
            </p:grpSpPr>
            <p:sp>
              <p:nvSpPr>
                <p:cNvPr id="38" name="Freeform 410"/>
                <p:cNvSpPr>
                  <a:spLocks/>
                </p:cNvSpPr>
                <p:nvPr/>
              </p:nvSpPr>
              <p:spPr bwMode="auto">
                <a:xfrm flipH="1">
                  <a:off x="1170242" y="2959311"/>
                  <a:ext cx="515361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" name="Freeform 410"/>
                <p:cNvSpPr>
                  <a:spLocks/>
                </p:cNvSpPr>
                <p:nvPr/>
              </p:nvSpPr>
              <p:spPr bwMode="auto">
                <a:xfrm flipH="1">
                  <a:off x="2218148" y="2959311"/>
                  <a:ext cx="788200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" name="Freeform 410"/>
                <p:cNvSpPr>
                  <a:spLocks/>
                </p:cNvSpPr>
                <p:nvPr/>
              </p:nvSpPr>
              <p:spPr bwMode="auto">
                <a:xfrm flipH="1">
                  <a:off x="3275760" y="2959311"/>
                  <a:ext cx="610402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" name="Freeform 410"/>
                <p:cNvSpPr>
                  <a:spLocks/>
                </p:cNvSpPr>
                <p:nvPr/>
              </p:nvSpPr>
              <p:spPr bwMode="auto">
                <a:xfrm flipH="1">
                  <a:off x="5033269" y="2959311"/>
                  <a:ext cx="358513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rgbClr val="0070C0"/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" name="Freeform 410"/>
                <p:cNvSpPr>
                  <a:spLocks/>
                </p:cNvSpPr>
                <p:nvPr/>
              </p:nvSpPr>
              <p:spPr bwMode="auto">
                <a:xfrm flipH="1">
                  <a:off x="7221786" y="2959311"/>
                  <a:ext cx="685250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" name="Freeform 410"/>
                <p:cNvSpPr>
                  <a:spLocks/>
                </p:cNvSpPr>
                <p:nvPr/>
              </p:nvSpPr>
              <p:spPr bwMode="auto">
                <a:xfrm flipH="1">
                  <a:off x="7944342" y="2959311"/>
                  <a:ext cx="716122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" name="Freeform 410"/>
                <p:cNvSpPr>
                  <a:spLocks/>
                </p:cNvSpPr>
                <p:nvPr/>
              </p:nvSpPr>
              <p:spPr bwMode="auto">
                <a:xfrm flipH="1">
                  <a:off x="3135025" y="2959311"/>
                  <a:ext cx="103429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31" name="Group 30"/>
              <p:cNvGrpSpPr/>
              <p:nvPr/>
            </p:nvGrpSpPr>
            <p:grpSpPr>
              <a:xfrm>
                <a:off x="1147430" y="3246836"/>
                <a:ext cx="7618872" cy="250914"/>
                <a:chOff x="1147430" y="3246836"/>
                <a:chExt cx="7618872" cy="250914"/>
              </a:xfrm>
            </p:grpSpPr>
            <p:sp>
              <p:nvSpPr>
                <p:cNvPr id="32" name="Freeform 410"/>
                <p:cNvSpPr>
                  <a:spLocks/>
                </p:cNvSpPr>
                <p:nvPr/>
              </p:nvSpPr>
              <p:spPr bwMode="auto">
                <a:xfrm>
                  <a:off x="1147430" y="3246836"/>
                  <a:ext cx="300529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3" name="Freeform 410"/>
                <p:cNvSpPr>
                  <a:spLocks/>
                </p:cNvSpPr>
                <p:nvPr/>
              </p:nvSpPr>
              <p:spPr bwMode="auto">
                <a:xfrm>
                  <a:off x="3273518" y="3246836"/>
                  <a:ext cx="1082609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" name="Freeform 410"/>
                <p:cNvSpPr>
                  <a:spLocks/>
                </p:cNvSpPr>
                <p:nvPr/>
              </p:nvSpPr>
              <p:spPr bwMode="auto">
                <a:xfrm>
                  <a:off x="6000796" y="3246836"/>
                  <a:ext cx="572204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" name="Freeform 410"/>
                <p:cNvSpPr>
                  <a:spLocks/>
                </p:cNvSpPr>
                <p:nvPr/>
              </p:nvSpPr>
              <p:spPr bwMode="auto">
                <a:xfrm>
                  <a:off x="8004203" y="3246836"/>
                  <a:ext cx="344752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6" name="Freeform 410"/>
                <p:cNvSpPr>
                  <a:spLocks/>
                </p:cNvSpPr>
                <p:nvPr/>
              </p:nvSpPr>
              <p:spPr bwMode="auto">
                <a:xfrm>
                  <a:off x="4821240" y="3246836"/>
                  <a:ext cx="1143528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" name="Freeform 410"/>
                <p:cNvSpPr>
                  <a:spLocks/>
                </p:cNvSpPr>
                <p:nvPr/>
              </p:nvSpPr>
              <p:spPr bwMode="auto">
                <a:xfrm>
                  <a:off x="8421550" y="3246836"/>
                  <a:ext cx="344752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cxnSp>
          <p:nvCxnSpPr>
            <p:cNvPr id="27" name="Straight Arrow Connector 26"/>
            <p:cNvCxnSpPr/>
            <p:nvPr/>
          </p:nvCxnSpPr>
          <p:spPr>
            <a:xfrm flipH="1" flipV="1">
              <a:off x="8599593" y="3514435"/>
              <a:ext cx="20740" cy="1377267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1845203" y="3912958"/>
              <a:ext cx="10700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othetica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479768" y="3591721"/>
              <a:ext cx="798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or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82829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30407" y="1281431"/>
            <a:ext cx="71477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 Rsp673_21385  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 regulator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sR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amily</a:t>
            </a:r>
          </a:p>
        </p:txBody>
      </p:sp>
      <p:grpSp>
        <p:nvGrpSpPr>
          <p:cNvPr id="37" name="Group 36"/>
          <p:cNvGrpSpPr/>
          <p:nvPr/>
        </p:nvGrpSpPr>
        <p:grpSpPr>
          <a:xfrm>
            <a:off x="162405" y="2201909"/>
            <a:ext cx="8742989" cy="2795865"/>
            <a:chOff x="162405" y="2201909"/>
            <a:chExt cx="8742989" cy="2795865"/>
          </a:xfrm>
        </p:grpSpPr>
        <p:grpSp>
          <p:nvGrpSpPr>
            <p:cNvPr id="3" name="Group 2"/>
            <p:cNvGrpSpPr/>
            <p:nvPr/>
          </p:nvGrpSpPr>
          <p:grpSpPr>
            <a:xfrm>
              <a:off x="162405" y="2509920"/>
              <a:ext cx="8742989" cy="2487854"/>
              <a:chOff x="162405" y="2509920"/>
              <a:chExt cx="8742989" cy="2487854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62405" y="3828070"/>
                <a:ext cx="164576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usA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elongation factor 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032614" y="4516312"/>
                <a:ext cx="201722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rp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nr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family transcriptional regulator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H="1" flipV="1">
                <a:off x="930225" y="3428622"/>
                <a:ext cx="2832" cy="471208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Arrow Connector 6"/>
              <p:cNvCxnSpPr/>
              <p:nvPr/>
            </p:nvCxnSpPr>
            <p:spPr>
              <a:xfrm flipH="1" flipV="1">
                <a:off x="2056932" y="3445681"/>
                <a:ext cx="15369" cy="109434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2573369" y="3761331"/>
                <a:ext cx="14481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Fe-4S ferredox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H="1" flipV="1">
                <a:off x="3253629" y="3453240"/>
                <a:ext cx="1104" cy="37483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Arrow Connector 9"/>
              <p:cNvCxnSpPr/>
              <p:nvPr/>
            </p:nvCxnSpPr>
            <p:spPr>
              <a:xfrm flipV="1">
                <a:off x="2616270" y="3180247"/>
                <a:ext cx="14072" cy="94100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/>
              <p:cNvCxnSpPr/>
              <p:nvPr/>
            </p:nvCxnSpPr>
            <p:spPr>
              <a:xfrm>
                <a:off x="4904030" y="2509920"/>
                <a:ext cx="7264" cy="421452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3491676" y="4020040"/>
                <a:ext cx="16294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mbrane prote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188724" y="3483678"/>
                <a:ext cx="69706" cy="488739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4759013" y="3642320"/>
                <a:ext cx="162692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ulfate ABC transporter ATP-bindin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170311" y="4720775"/>
                <a:ext cx="247933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phonoacetaldehyde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hydrol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Straight Arrow Connector 15"/>
              <p:cNvCxnSpPr/>
              <p:nvPr/>
            </p:nvCxnSpPr>
            <p:spPr>
              <a:xfrm flipV="1">
                <a:off x="5614105" y="3153371"/>
                <a:ext cx="341315" cy="487284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/>
              <p:cNvCxnSpPr/>
              <p:nvPr/>
            </p:nvCxnSpPr>
            <p:spPr>
              <a:xfrm flipH="1" flipV="1">
                <a:off x="7427817" y="3197660"/>
                <a:ext cx="20947" cy="148628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5770834" y="4183602"/>
                <a:ext cx="176271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nate ABC transporter permease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Straight Arrow Connector 18"/>
              <p:cNvCxnSpPr/>
              <p:nvPr/>
            </p:nvCxnSpPr>
            <p:spPr>
              <a:xfrm flipV="1">
                <a:off x="6668040" y="3197660"/>
                <a:ext cx="83905" cy="923592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1981316" y="4029185"/>
                <a:ext cx="16294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mbrane prote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Group 20"/>
              <p:cNvGrpSpPr/>
              <p:nvPr/>
            </p:nvGrpSpPr>
            <p:grpSpPr>
              <a:xfrm>
                <a:off x="240089" y="2935599"/>
                <a:ext cx="8233813" cy="531997"/>
                <a:chOff x="623365" y="2946231"/>
                <a:chExt cx="8233813" cy="531997"/>
              </a:xfrm>
            </p:grpSpPr>
            <p:grpSp>
              <p:nvGrpSpPr>
                <p:cNvPr id="24" name="Group 23"/>
                <p:cNvGrpSpPr/>
                <p:nvPr/>
              </p:nvGrpSpPr>
              <p:grpSpPr>
                <a:xfrm>
                  <a:off x="623365" y="3227314"/>
                  <a:ext cx="4367456" cy="250914"/>
                  <a:chOff x="623365" y="3227314"/>
                  <a:chExt cx="4367456" cy="250914"/>
                </a:xfrm>
              </p:grpSpPr>
              <p:sp>
                <p:nvSpPr>
                  <p:cNvPr id="32" name="Freeform 410"/>
                  <p:cNvSpPr>
                    <a:spLocks/>
                  </p:cNvSpPr>
                  <p:nvPr/>
                </p:nvSpPr>
                <p:spPr bwMode="auto">
                  <a:xfrm>
                    <a:off x="2176094" y="3227314"/>
                    <a:ext cx="477150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" name="Freeform 410"/>
                  <p:cNvSpPr>
                    <a:spLocks/>
                  </p:cNvSpPr>
                  <p:nvPr/>
                </p:nvSpPr>
                <p:spPr bwMode="auto">
                  <a:xfrm>
                    <a:off x="623365" y="3227314"/>
                    <a:ext cx="1477665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" name="Freeform 410"/>
                  <p:cNvSpPr>
                    <a:spLocks/>
                  </p:cNvSpPr>
                  <p:nvPr/>
                </p:nvSpPr>
                <p:spPr bwMode="auto">
                  <a:xfrm>
                    <a:off x="3369365" y="3227314"/>
                    <a:ext cx="477822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" name="Freeform 410"/>
                  <p:cNvSpPr>
                    <a:spLocks/>
                  </p:cNvSpPr>
                  <p:nvPr/>
                </p:nvSpPr>
                <p:spPr bwMode="auto">
                  <a:xfrm>
                    <a:off x="3908212" y="3227314"/>
                    <a:ext cx="108260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25" name="Group 24"/>
                <p:cNvGrpSpPr/>
                <p:nvPr/>
              </p:nvGrpSpPr>
              <p:grpSpPr>
                <a:xfrm>
                  <a:off x="2724115" y="2946231"/>
                  <a:ext cx="6133063" cy="250914"/>
                  <a:chOff x="2724115" y="2946231"/>
                  <a:chExt cx="6133063" cy="250914"/>
                </a:xfrm>
              </p:grpSpPr>
              <p:sp>
                <p:nvSpPr>
                  <p:cNvPr id="26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2724115" y="2946231"/>
                    <a:ext cx="600343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5033269" y="2946231"/>
                    <a:ext cx="876476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solidFill>
                    <a:srgbClr val="0070C0"/>
                  </a:solidFill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061091" y="2946231"/>
                    <a:ext cx="685250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742806" y="2946231"/>
                    <a:ext cx="854942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7642051" y="2946231"/>
                    <a:ext cx="59143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solidFill>
                    <a:schemeClr val="accent1">
                      <a:lumMod val="75000"/>
                    </a:schemeClr>
                  </a:solidFill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8265739" y="2946231"/>
                    <a:ext cx="59143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solidFill>
                    <a:schemeClr val="accent1">
                      <a:lumMod val="75000"/>
                    </a:schemeClr>
                  </a:solidFill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</p:grpSp>
          <p:cxnSp>
            <p:nvCxnSpPr>
              <p:cNvPr id="22" name="Straight Arrow Connector 21"/>
              <p:cNvCxnSpPr/>
              <p:nvPr/>
            </p:nvCxnSpPr>
            <p:spPr>
              <a:xfrm flipH="1" flipV="1">
                <a:off x="8047862" y="3153371"/>
                <a:ext cx="18146" cy="760743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7395151" y="3844579"/>
                <a:ext cx="151024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nate ABC transporter substrate bindin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4188724" y="2201909"/>
              <a:ext cx="16294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p673_2138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33330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39198" y="1323051"/>
            <a:ext cx="76886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 Rsp673_22445  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 regulator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sR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amily</a:t>
            </a:r>
          </a:p>
        </p:txBody>
      </p:sp>
      <p:grpSp>
        <p:nvGrpSpPr>
          <p:cNvPr id="36" name="Group 35"/>
          <p:cNvGrpSpPr/>
          <p:nvPr/>
        </p:nvGrpSpPr>
        <p:grpSpPr>
          <a:xfrm>
            <a:off x="116318" y="2224142"/>
            <a:ext cx="9027682" cy="2317618"/>
            <a:chOff x="116318" y="2224142"/>
            <a:chExt cx="9027682" cy="2317618"/>
          </a:xfrm>
        </p:grpSpPr>
        <p:grpSp>
          <p:nvGrpSpPr>
            <p:cNvPr id="3" name="Group 2"/>
            <p:cNvGrpSpPr/>
            <p:nvPr/>
          </p:nvGrpSpPr>
          <p:grpSpPr>
            <a:xfrm>
              <a:off x="116318" y="2509920"/>
              <a:ext cx="9027682" cy="2031840"/>
              <a:chOff x="116318" y="2509920"/>
              <a:chExt cx="9027682" cy="2031840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16318" y="3828070"/>
                <a:ext cx="164576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usA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elongation factor 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254191" y="4080095"/>
                <a:ext cx="201722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rp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nr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family transcriptional regulator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H="1" flipV="1">
                <a:off x="884138" y="3428622"/>
                <a:ext cx="2832" cy="471208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Arrow Connector 6"/>
              <p:cNvCxnSpPr/>
              <p:nvPr/>
            </p:nvCxnSpPr>
            <p:spPr>
              <a:xfrm flipH="1" flipV="1">
                <a:off x="2010846" y="3445682"/>
                <a:ext cx="6542" cy="606722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2975456" y="3804729"/>
                <a:ext cx="10945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pothetical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H="1" flipV="1">
                <a:off x="3494934" y="3463334"/>
                <a:ext cx="1104" cy="37483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Arrow Connector 9"/>
              <p:cNvCxnSpPr/>
              <p:nvPr/>
            </p:nvCxnSpPr>
            <p:spPr>
              <a:xfrm flipH="1" flipV="1">
                <a:off x="2584255" y="3180248"/>
                <a:ext cx="813171" cy="657916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/>
              <p:cNvCxnSpPr/>
              <p:nvPr/>
            </p:nvCxnSpPr>
            <p:spPr>
              <a:xfrm>
                <a:off x="4857943" y="2509920"/>
                <a:ext cx="7264" cy="421452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>
              <a:xfrm flipV="1">
                <a:off x="3649173" y="3463336"/>
                <a:ext cx="669240" cy="364734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4909260" y="3576913"/>
                <a:ext cx="16269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NA binding prote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227053" y="3784200"/>
                <a:ext cx="12218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gnal peptide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5568018" y="3153371"/>
                <a:ext cx="341315" cy="487284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/>
              <p:cNvCxnSpPr/>
              <p:nvPr/>
            </p:nvCxnSpPr>
            <p:spPr>
              <a:xfrm flipH="1" flipV="1">
                <a:off x="7435099" y="3156886"/>
                <a:ext cx="221693" cy="944073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7139944" y="4114034"/>
                <a:ext cx="11393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othetical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6862964" y="3177367"/>
                <a:ext cx="57022" cy="53804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/>
              <p:cNvCxnSpPr/>
              <p:nvPr/>
            </p:nvCxnSpPr>
            <p:spPr>
              <a:xfrm flipH="1" flipV="1">
                <a:off x="8554512" y="3177368"/>
                <a:ext cx="20690" cy="399545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7939771" y="3647334"/>
                <a:ext cx="120422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ys R transcriptional regulator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Group 20"/>
              <p:cNvGrpSpPr/>
              <p:nvPr/>
            </p:nvGrpSpPr>
            <p:grpSpPr>
              <a:xfrm>
                <a:off x="194002" y="2931901"/>
                <a:ext cx="8767980" cy="545919"/>
                <a:chOff x="240089" y="2931901"/>
                <a:chExt cx="8767980" cy="545919"/>
              </a:xfrm>
            </p:grpSpPr>
            <p:grpSp>
              <p:nvGrpSpPr>
                <p:cNvPr id="23" name="Group 22"/>
                <p:cNvGrpSpPr/>
                <p:nvPr/>
              </p:nvGrpSpPr>
              <p:grpSpPr>
                <a:xfrm>
                  <a:off x="240089" y="3224968"/>
                  <a:ext cx="4367456" cy="252852"/>
                  <a:chOff x="240089" y="3224968"/>
                  <a:chExt cx="4367456" cy="252852"/>
                </a:xfrm>
              </p:grpSpPr>
              <p:sp>
                <p:nvSpPr>
                  <p:cNvPr id="32" name="Freeform 410"/>
                  <p:cNvSpPr>
                    <a:spLocks/>
                  </p:cNvSpPr>
                  <p:nvPr/>
                </p:nvSpPr>
                <p:spPr bwMode="auto">
                  <a:xfrm>
                    <a:off x="240089" y="3230080"/>
                    <a:ext cx="2079549" cy="242628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" name="Freeform 410"/>
                  <p:cNvSpPr>
                    <a:spLocks/>
                  </p:cNvSpPr>
                  <p:nvPr/>
                </p:nvSpPr>
                <p:spPr bwMode="auto">
                  <a:xfrm>
                    <a:off x="3374736" y="3224968"/>
                    <a:ext cx="270657" cy="252852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" name="Freeform 410"/>
                  <p:cNvSpPr>
                    <a:spLocks/>
                  </p:cNvSpPr>
                  <p:nvPr/>
                </p:nvSpPr>
                <p:spPr bwMode="auto">
                  <a:xfrm>
                    <a:off x="3687062" y="3230081"/>
                    <a:ext cx="920483" cy="242627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24" name="Group 23"/>
                <p:cNvGrpSpPr/>
                <p:nvPr/>
              </p:nvGrpSpPr>
              <p:grpSpPr>
                <a:xfrm>
                  <a:off x="2366559" y="2931901"/>
                  <a:ext cx="6641510" cy="266288"/>
                  <a:chOff x="2366559" y="2931901"/>
                  <a:chExt cx="6641510" cy="266288"/>
                </a:xfrm>
              </p:grpSpPr>
              <p:sp>
                <p:nvSpPr>
                  <p:cNvPr id="25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2366559" y="2931901"/>
                    <a:ext cx="875597" cy="266288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4649993" y="2939588"/>
                    <a:ext cx="876476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solidFill>
                    <a:srgbClr val="0070C0"/>
                  </a:solidFill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5987669" y="2937475"/>
                    <a:ext cx="375396" cy="255141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6934406" y="2938531"/>
                    <a:ext cx="171395" cy="253028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7139726" y="2939588"/>
                    <a:ext cx="710487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7882463" y="2939588"/>
                    <a:ext cx="591439" cy="250914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" name="Freeform 410"/>
                  <p:cNvSpPr>
                    <a:spLocks/>
                  </p:cNvSpPr>
                  <p:nvPr/>
                </p:nvSpPr>
                <p:spPr bwMode="auto">
                  <a:xfrm flipH="1">
                    <a:off x="8481561" y="2935745"/>
                    <a:ext cx="526508" cy="258601"/>
                  </a:xfrm>
                  <a:custGeom>
                    <a:avLst/>
                    <a:gdLst>
                      <a:gd name="T0" fmla="*/ 169 w 169"/>
                      <a:gd name="T1" fmla="*/ 62 h 83"/>
                      <a:gd name="T2" fmla="*/ 41 w 169"/>
                      <a:gd name="T3" fmla="*/ 62 h 83"/>
                      <a:gd name="T4" fmla="*/ 41 w 169"/>
                      <a:gd name="T5" fmla="*/ 83 h 83"/>
                      <a:gd name="T6" fmla="*/ 0 w 169"/>
                      <a:gd name="T7" fmla="*/ 42 h 83"/>
                      <a:gd name="T8" fmla="*/ 41 w 169"/>
                      <a:gd name="T9" fmla="*/ 0 h 83"/>
                      <a:gd name="T10" fmla="*/ 41 w 169"/>
                      <a:gd name="T11" fmla="*/ 21 h 83"/>
                      <a:gd name="T12" fmla="*/ 169 w 169"/>
                      <a:gd name="T13" fmla="*/ 21 h 83"/>
                      <a:gd name="T14" fmla="*/ 169 w 169"/>
                      <a:gd name="T15" fmla="*/ 62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69" h="83">
                        <a:moveTo>
                          <a:pt x="169" y="62"/>
                        </a:moveTo>
                        <a:lnTo>
                          <a:pt x="41" y="62"/>
                        </a:lnTo>
                        <a:lnTo>
                          <a:pt x="41" y="83"/>
                        </a:lnTo>
                        <a:lnTo>
                          <a:pt x="0" y="42"/>
                        </a:lnTo>
                        <a:lnTo>
                          <a:pt x="41" y="0"/>
                        </a:lnTo>
                        <a:lnTo>
                          <a:pt x="41" y="21"/>
                        </a:lnTo>
                        <a:lnTo>
                          <a:pt x="169" y="21"/>
                        </a:lnTo>
                        <a:lnTo>
                          <a:pt x="169" y="62"/>
                        </a:lnTo>
                        <a:close/>
                      </a:path>
                    </a:pathLst>
                  </a:custGeom>
                  <a:noFill/>
                  <a:ln w="19050" cap="flat">
                    <a:solidFill>
                      <a:srgbClr val="385D8A"/>
                    </a:solidFill>
                    <a:prstDash val="solid"/>
                    <a:miter lim="800000"/>
                    <a:headEnd/>
                    <a:tailEnd/>
                  </a:ln>
                  <a:extLst/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</p:grpSp>
          <p:cxnSp>
            <p:nvCxnSpPr>
              <p:cNvPr id="22" name="Straight Arrow Connector 21"/>
              <p:cNvCxnSpPr/>
              <p:nvPr/>
            </p:nvCxnSpPr>
            <p:spPr>
              <a:xfrm flipV="1">
                <a:off x="7709623" y="3177368"/>
                <a:ext cx="258499" cy="923591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" name="TextBox 34"/>
            <p:cNvSpPr txBox="1"/>
            <p:nvPr/>
          </p:nvSpPr>
          <p:spPr>
            <a:xfrm>
              <a:off x="4111746" y="2224142"/>
              <a:ext cx="16269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p673_2244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56292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40442" y="1590392"/>
            <a:ext cx="725080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) Rsp673_22045  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 only in cool virulent strains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0" y="2583483"/>
            <a:ext cx="9401577" cy="2399359"/>
            <a:chOff x="-68752" y="2590273"/>
            <a:chExt cx="9401577" cy="2399359"/>
          </a:xfrm>
        </p:grpSpPr>
        <p:sp>
          <p:nvSpPr>
            <p:cNvPr id="4" name="TextBox 3"/>
            <p:cNvSpPr txBox="1"/>
            <p:nvPr/>
          </p:nvSpPr>
          <p:spPr>
            <a:xfrm>
              <a:off x="98158" y="3562194"/>
              <a:ext cx="16457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kyl hydro peroxide reduct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785706" y="4068996"/>
              <a:ext cx="10400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othetica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H="1" flipV="1">
              <a:off x="1138902" y="3161408"/>
              <a:ext cx="2832" cy="471208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 flipH="1" flipV="1">
              <a:off x="1596201" y="3149083"/>
              <a:ext cx="17906" cy="840407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3645515" y="4205240"/>
              <a:ext cx="10945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FS transporte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 flipV="1">
              <a:off x="3250308" y="3102561"/>
              <a:ext cx="24828" cy="956341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 flipH="1" flipV="1">
              <a:off x="2649170" y="3080221"/>
              <a:ext cx="26813" cy="383363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 flipH="1" flipV="1">
              <a:off x="5363528" y="3127238"/>
              <a:ext cx="3446" cy="815990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H="1" flipV="1">
              <a:off x="4670605" y="3123631"/>
              <a:ext cx="18218" cy="527118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5555616" y="3490797"/>
              <a:ext cx="10903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-carnitine dehydrat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38547" y="3722954"/>
              <a:ext cx="967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ptid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>
              <a:stCxn id="13" idx="0"/>
            </p:cNvCxnSpPr>
            <p:nvPr/>
          </p:nvCxnSpPr>
          <p:spPr>
            <a:xfrm flipV="1">
              <a:off x="6100798" y="3094367"/>
              <a:ext cx="213720" cy="396430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 flipH="1" flipV="1">
              <a:off x="7573334" y="3168619"/>
              <a:ext cx="52950" cy="1051704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7831269" y="3758658"/>
              <a:ext cx="11393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mbrane prote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V="1">
              <a:off x="6632701" y="3156427"/>
              <a:ext cx="128601" cy="1002208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 flipH="1" flipV="1">
              <a:off x="8685129" y="2919295"/>
              <a:ext cx="20690" cy="399545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8128596" y="3258513"/>
              <a:ext cx="1204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drol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 flipV="1">
              <a:off x="8125449" y="3155710"/>
              <a:ext cx="14654" cy="682454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Group 21"/>
            <p:cNvGrpSpPr/>
            <p:nvPr/>
          </p:nvGrpSpPr>
          <p:grpSpPr>
            <a:xfrm>
              <a:off x="357630" y="2590273"/>
              <a:ext cx="8479136" cy="570804"/>
              <a:chOff x="357630" y="2590273"/>
              <a:chExt cx="8479136" cy="570804"/>
            </a:xfrm>
          </p:grpSpPr>
          <p:grpSp>
            <p:nvGrpSpPr>
              <p:cNvPr id="35" name="Group 34"/>
              <p:cNvGrpSpPr/>
              <p:nvPr/>
            </p:nvGrpSpPr>
            <p:grpSpPr>
              <a:xfrm>
                <a:off x="989512" y="2886175"/>
                <a:ext cx="7212306" cy="274902"/>
                <a:chOff x="989512" y="2886175"/>
                <a:chExt cx="7212306" cy="274902"/>
              </a:xfrm>
            </p:grpSpPr>
            <p:sp>
              <p:nvSpPr>
                <p:cNvPr id="39" name="Freeform 410"/>
                <p:cNvSpPr>
                  <a:spLocks/>
                </p:cNvSpPr>
                <p:nvPr/>
              </p:nvSpPr>
              <p:spPr bwMode="auto">
                <a:xfrm>
                  <a:off x="2105618" y="2886367"/>
                  <a:ext cx="980876" cy="274519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" name="Freeform 410"/>
                <p:cNvSpPr>
                  <a:spLocks/>
                </p:cNvSpPr>
                <p:nvPr/>
              </p:nvSpPr>
              <p:spPr bwMode="auto">
                <a:xfrm>
                  <a:off x="3102007" y="2897200"/>
                  <a:ext cx="270657" cy="252852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" name="Freeform 410"/>
                <p:cNvSpPr>
                  <a:spLocks/>
                </p:cNvSpPr>
                <p:nvPr/>
              </p:nvSpPr>
              <p:spPr bwMode="auto">
                <a:xfrm>
                  <a:off x="4926130" y="2895906"/>
                  <a:ext cx="877847" cy="255440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" name="Freeform 410"/>
                <p:cNvSpPr>
                  <a:spLocks/>
                </p:cNvSpPr>
                <p:nvPr/>
              </p:nvSpPr>
              <p:spPr bwMode="auto">
                <a:xfrm>
                  <a:off x="3403255" y="2890482"/>
                  <a:ext cx="484521" cy="266288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" name="Freeform 410"/>
                <p:cNvSpPr>
                  <a:spLocks/>
                </p:cNvSpPr>
                <p:nvPr/>
              </p:nvSpPr>
              <p:spPr bwMode="auto">
                <a:xfrm>
                  <a:off x="5836226" y="2898169"/>
                  <a:ext cx="876476" cy="250914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rgbClr val="0070C0"/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" name="Freeform 410"/>
                <p:cNvSpPr>
                  <a:spLocks/>
                </p:cNvSpPr>
                <p:nvPr/>
              </p:nvSpPr>
              <p:spPr bwMode="auto">
                <a:xfrm>
                  <a:off x="6738057" y="2894708"/>
                  <a:ext cx="206287" cy="257836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" name="Freeform 410"/>
                <p:cNvSpPr>
                  <a:spLocks/>
                </p:cNvSpPr>
                <p:nvPr/>
              </p:nvSpPr>
              <p:spPr bwMode="auto">
                <a:xfrm>
                  <a:off x="6971730" y="2886685"/>
                  <a:ext cx="208323" cy="273882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" name="Freeform 410"/>
                <p:cNvSpPr>
                  <a:spLocks/>
                </p:cNvSpPr>
                <p:nvPr/>
              </p:nvSpPr>
              <p:spPr bwMode="auto">
                <a:xfrm>
                  <a:off x="7208343" y="2886175"/>
                  <a:ext cx="710487" cy="274902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" name="Freeform 410"/>
                <p:cNvSpPr>
                  <a:spLocks/>
                </p:cNvSpPr>
                <p:nvPr/>
              </p:nvSpPr>
              <p:spPr bwMode="auto">
                <a:xfrm>
                  <a:off x="8043175" y="2896248"/>
                  <a:ext cx="158643" cy="254757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" name="Freeform 410"/>
                <p:cNvSpPr>
                  <a:spLocks/>
                </p:cNvSpPr>
                <p:nvPr/>
              </p:nvSpPr>
              <p:spPr bwMode="auto">
                <a:xfrm>
                  <a:off x="4406634" y="2890482"/>
                  <a:ext cx="484521" cy="266288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" name="Freeform 410"/>
                <p:cNvSpPr>
                  <a:spLocks/>
                </p:cNvSpPr>
                <p:nvPr/>
              </p:nvSpPr>
              <p:spPr bwMode="auto">
                <a:xfrm>
                  <a:off x="3910122" y="2890482"/>
                  <a:ext cx="484521" cy="266288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solidFill>
                  <a:schemeClr val="accent1">
                    <a:lumMod val="75000"/>
                  </a:schemeClr>
                </a:solidFill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" name="Freeform 410"/>
                <p:cNvSpPr>
                  <a:spLocks/>
                </p:cNvSpPr>
                <p:nvPr/>
              </p:nvSpPr>
              <p:spPr bwMode="auto">
                <a:xfrm>
                  <a:off x="1324223" y="2890482"/>
                  <a:ext cx="484521" cy="266288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" name="Freeform 410"/>
                <p:cNvSpPr>
                  <a:spLocks/>
                </p:cNvSpPr>
                <p:nvPr/>
              </p:nvSpPr>
              <p:spPr bwMode="auto">
                <a:xfrm>
                  <a:off x="989512" y="2897200"/>
                  <a:ext cx="270657" cy="252852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36" name="Group 35"/>
              <p:cNvGrpSpPr/>
              <p:nvPr/>
            </p:nvGrpSpPr>
            <p:grpSpPr>
              <a:xfrm>
                <a:off x="357630" y="2590273"/>
                <a:ext cx="8479136" cy="258601"/>
                <a:chOff x="357630" y="2590273"/>
                <a:chExt cx="8479136" cy="258601"/>
              </a:xfrm>
            </p:grpSpPr>
            <p:sp>
              <p:nvSpPr>
                <p:cNvPr id="37" name="Freeform 410"/>
                <p:cNvSpPr>
                  <a:spLocks/>
                </p:cNvSpPr>
                <p:nvPr/>
              </p:nvSpPr>
              <p:spPr bwMode="auto">
                <a:xfrm flipH="1">
                  <a:off x="8310258" y="2590273"/>
                  <a:ext cx="526508" cy="258601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" name="Freeform 410"/>
                <p:cNvSpPr>
                  <a:spLocks/>
                </p:cNvSpPr>
                <p:nvPr/>
              </p:nvSpPr>
              <p:spPr bwMode="auto">
                <a:xfrm flipH="1">
                  <a:off x="357630" y="2590273"/>
                  <a:ext cx="526508" cy="258601"/>
                </a:xfrm>
                <a:custGeom>
                  <a:avLst/>
                  <a:gdLst>
                    <a:gd name="T0" fmla="*/ 169 w 169"/>
                    <a:gd name="T1" fmla="*/ 62 h 83"/>
                    <a:gd name="T2" fmla="*/ 41 w 169"/>
                    <a:gd name="T3" fmla="*/ 62 h 83"/>
                    <a:gd name="T4" fmla="*/ 41 w 169"/>
                    <a:gd name="T5" fmla="*/ 83 h 83"/>
                    <a:gd name="T6" fmla="*/ 0 w 169"/>
                    <a:gd name="T7" fmla="*/ 42 h 83"/>
                    <a:gd name="T8" fmla="*/ 41 w 169"/>
                    <a:gd name="T9" fmla="*/ 0 h 83"/>
                    <a:gd name="T10" fmla="*/ 41 w 169"/>
                    <a:gd name="T11" fmla="*/ 21 h 83"/>
                    <a:gd name="T12" fmla="*/ 169 w 169"/>
                    <a:gd name="T13" fmla="*/ 21 h 83"/>
                    <a:gd name="T14" fmla="*/ 169 w 169"/>
                    <a:gd name="T15" fmla="*/ 62 h 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169" h="83">
                      <a:moveTo>
                        <a:pt x="169" y="62"/>
                      </a:moveTo>
                      <a:lnTo>
                        <a:pt x="41" y="62"/>
                      </a:lnTo>
                      <a:lnTo>
                        <a:pt x="41" y="83"/>
                      </a:lnTo>
                      <a:lnTo>
                        <a:pt x="0" y="42"/>
                      </a:lnTo>
                      <a:lnTo>
                        <a:pt x="41" y="0"/>
                      </a:lnTo>
                      <a:lnTo>
                        <a:pt x="41" y="21"/>
                      </a:lnTo>
                      <a:lnTo>
                        <a:pt x="169" y="21"/>
                      </a:lnTo>
                      <a:lnTo>
                        <a:pt x="169" y="62"/>
                      </a:lnTo>
                      <a:close/>
                    </a:path>
                  </a:pathLst>
                </a:custGeom>
                <a:noFill/>
                <a:ln w="19050" cap="flat">
                  <a:solidFill>
                    <a:srgbClr val="385D8A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sp>
          <p:nvSpPr>
            <p:cNvPr id="23" name="TextBox 22"/>
            <p:cNvSpPr txBox="1"/>
            <p:nvPr/>
          </p:nvSpPr>
          <p:spPr>
            <a:xfrm>
              <a:off x="7015369" y="4158635"/>
              <a:ext cx="1221829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olybdopterin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ynthesis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oeZ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04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 flipV="1">
              <a:off x="7047060" y="3181149"/>
              <a:ext cx="57022" cy="538045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5933357" y="4146331"/>
              <a:ext cx="1221829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lybdenum cofactor biosynthesis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oa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885073" y="3923812"/>
              <a:ext cx="109036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MP-dependent synth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030208" y="3607331"/>
              <a:ext cx="13333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yl-CoA dehydrogen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Straight Arrow Connector 27"/>
            <p:cNvCxnSpPr/>
            <p:nvPr/>
          </p:nvCxnSpPr>
          <p:spPr>
            <a:xfrm flipH="1" flipV="1">
              <a:off x="3657695" y="3115967"/>
              <a:ext cx="1104" cy="374830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flipH="1" flipV="1">
              <a:off x="4150302" y="3151005"/>
              <a:ext cx="16553" cy="1095972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3150063" y="3496169"/>
              <a:ext cx="10945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ucuronyl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hydrolas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075035" y="3450171"/>
              <a:ext cx="116987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gand gated channel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0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241284" y="4020135"/>
              <a:ext cx="10400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othetica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-68752" y="3055857"/>
              <a:ext cx="11698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oride channe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Straight Arrow Connector 33"/>
            <p:cNvCxnSpPr>
              <a:stCxn id="33" idx="0"/>
            </p:cNvCxnSpPr>
            <p:nvPr/>
          </p:nvCxnSpPr>
          <p:spPr>
            <a:xfrm flipV="1">
              <a:off x="516185" y="2775764"/>
              <a:ext cx="30774" cy="280093"/>
            </a:xfrm>
            <a:prstGeom prst="straightConnector1">
              <a:avLst/>
            </a:prstGeom>
            <a:ln w="28575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/>
          <p:cNvSpPr txBox="1"/>
          <p:nvPr/>
        </p:nvSpPr>
        <p:spPr>
          <a:xfrm>
            <a:off x="463639" y="489397"/>
            <a:ext cx="8165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Adjacent genes to the transcriptional regulator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only in CV strains.</a:t>
            </a:r>
            <a:endParaRPr 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3696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588E34E7-8643-4800-9F32-6A11F647AFDA}"/>
</file>

<file path=customXml/itemProps2.xml><?xml version="1.0" encoding="utf-8"?>
<ds:datastoreItem xmlns:ds="http://schemas.openxmlformats.org/officeDocument/2006/customXml" ds:itemID="{D6107E29-E87A-4B38-9BC8-A9FCAFA6AAEB}"/>
</file>

<file path=customXml/itemProps3.xml><?xml version="1.0" encoding="utf-8"?>
<ds:datastoreItem xmlns:ds="http://schemas.openxmlformats.org/officeDocument/2006/customXml" ds:itemID="{568E33CA-0487-4C54-991F-445999771D7D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357</Words>
  <Application>Microsoft Office PowerPoint</Application>
  <PresentationFormat>On-screen Show (4:3)</PresentationFormat>
  <Paragraphs>10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csanczy,Ana Maria Burducea</dc:creator>
  <cp:lastModifiedBy>Bocsanczy,Ana Maria</cp:lastModifiedBy>
  <cp:revision>7</cp:revision>
  <dcterms:created xsi:type="dcterms:W3CDTF">2016-10-28T17:51:41Z</dcterms:created>
  <dcterms:modified xsi:type="dcterms:W3CDTF">2017-03-20T15:27:14Z</dcterms:modified>
</cp:coreProperties>
</file>